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5486400" cy="4572000"/>
  <p:notesSz cx="6858000" cy="9144000"/>
  <p:defaultTextStyle>
    <a:defPPr>
      <a:defRPr lang="en-US"/>
    </a:defPPr>
    <a:lvl1pPr marL="0" algn="l" defTabSz="67921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339608" algn="l" defTabSz="67921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679216" algn="l" defTabSz="67921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1018824" algn="l" defTabSz="67921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1358433" algn="l" defTabSz="67921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1698041" algn="l" defTabSz="67921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2037649" algn="l" defTabSz="67921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2377257" algn="l" defTabSz="67921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2716865" algn="l" defTabSz="679216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60" d="100"/>
          <a:sy n="160" d="100"/>
        </p:scale>
        <p:origin x="-1716" y="-90"/>
      </p:cViewPr>
      <p:guideLst>
        <p:guide orient="horz" pos="1440"/>
        <p:guide pos="172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spPr>
            <a:ln w="38100">
              <a:solidFill>
                <a:schemeClr val="tx1"/>
              </a:solidFill>
            </a:ln>
          </c:spPr>
          <c:marker>
            <c:symbol val="none"/>
          </c:marker>
          <c:val>
            <c:numRef>
              <c:f>'[Chart in Microsoft PowerPoint]Sheet2'!$E$5:$E$14</c:f>
              <c:numCache>
                <c:formatCode>General</c:formatCode>
                <c:ptCount val="1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</c:numCache>
            </c:numRef>
          </c:val>
          <c:smooth val="0"/>
        </c:ser>
        <c:ser>
          <c:idx val="1"/>
          <c:order val="1"/>
          <c:spPr>
            <a:ln w="38100" cap="flat" cmpd="sng" algn="ctr">
              <a:solidFill>
                <a:schemeClr val="dk1"/>
              </a:solidFill>
              <a:prstDash val="solid"/>
            </a:ln>
            <a:effectLst/>
          </c:spPr>
          <c:marker>
            <c:symbol val="none"/>
          </c:marker>
          <c:val>
            <c:numRef>
              <c:f>'[Chart in Microsoft PowerPoint]Sheet2'!$F$5:$F$14</c:f>
              <c:numCache>
                <c:formatCode>General</c:formatCode>
                <c:ptCount val="10"/>
                <c:pt idx="0">
                  <c:v>-3121396.4333333336</c:v>
                </c:pt>
                <c:pt idx="1">
                  <c:v>-2770823.4333333299</c:v>
                </c:pt>
                <c:pt idx="2">
                  <c:v>-2585677.7000000002</c:v>
                </c:pt>
                <c:pt idx="3">
                  <c:v>-2505962.9333333336</c:v>
                </c:pt>
                <c:pt idx="4">
                  <c:v>-2414422.2666666666</c:v>
                </c:pt>
                <c:pt idx="5">
                  <c:v>-2347249.6749999998</c:v>
                </c:pt>
                <c:pt idx="6">
                  <c:v>-2285092.0333333332</c:v>
                </c:pt>
                <c:pt idx="7">
                  <c:v>-2221149.6</c:v>
                </c:pt>
                <c:pt idx="8">
                  <c:v>-2225664.4666666701</c:v>
                </c:pt>
                <c:pt idx="9">
                  <c:v>-2225690.700000000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9453312"/>
        <c:axId val="89454848"/>
      </c:lineChart>
      <c:catAx>
        <c:axId val="89453312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38100">
            <a:solidFill>
              <a:schemeClr val="tx1"/>
            </a:solidFill>
          </a:ln>
        </c:spPr>
        <c:txPr>
          <a:bodyPr/>
          <a:lstStyle/>
          <a:p>
            <a:pPr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89454848"/>
        <c:crosses val="autoZero"/>
        <c:auto val="1"/>
        <c:lblAlgn val="ctr"/>
        <c:lblOffset val="100"/>
        <c:noMultiLvlLbl val="0"/>
      </c:catAx>
      <c:valAx>
        <c:axId val="89454848"/>
        <c:scaling>
          <c:orientation val="minMax"/>
          <c:min val="-35000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38100" cmpd="sng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89453312"/>
        <c:crosses val="autoZero"/>
        <c:crossBetween val="between"/>
        <c:minorUnit val="100000"/>
      </c:valAx>
      <c:spPr>
        <a:ln w="12700" cmpd="sng"/>
      </c:spPr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11480" y="1420284"/>
            <a:ext cx="4663440" cy="9800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22960" y="2590800"/>
            <a:ext cx="3840480" cy="11684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396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792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188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5843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6980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376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3772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168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7E52E-931C-4507-944B-6ED7C09526FE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52905-D9BA-43FD-B8CB-B5F87BD853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2756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7E52E-931C-4507-944B-6ED7C09526FE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52905-D9BA-43FD-B8CB-B5F87BD853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90215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182303" y="121709"/>
            <a:ext cx="987743" cy="260138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19076" y="121709"/>
            <a:ext cx="2871788" cy="260138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7E52E-931C-4507-944B-6ED7C09526FE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52905-D9BA-43FD-B8CB-B5F87BD853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11792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7E52E-931C-4507-944B-6ED7C09526FE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52905-D9BA-43FD-B8CB-B5F87BD853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49322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3387" y="2937934"/>
            <a:ext cx="4663440" cy="90805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3387" y="1937810"/>
            <a:ext cx="4663440" cy="1000125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39608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2pPr>
            <a:lvl3pPr marL="67921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18824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4pPr>
            <a:lvl5pPr marL="1358433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5pPr>
            <a:lvl6pPr marL="1698041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6pPr>
            <a:lvl7pPr marL="2037649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7pPr>
            <a:lvl8pPr marL="2377257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8pPr>
            <a:lvl9pPr marL="2716865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7E52E-931C-4507-944B-6ED7C09526FE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52905-D9BA-43FD-B8CB-B5F87BD853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138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19075" y="711200"/>
            <a:ext cx="1929765" cy="201189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240280" y="711200"/>
            <a:ext cx="1929765" cy="201189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7E52E-931C-4507-944B-6ED7C09526FE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52905-D9BA-43FD-B8CB-B5F87BD853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23664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74320" y="183092"/>
            <a:ext cx="4937760" cy="762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74320" y="1023409"/>
            <a:ext cx="2424113" cy="426508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39608" indent="0">
              <a:buNone/>
              <a:defRPr sz="1500" b="1"/>
            </a:lvl2pPr>
            <a:lvl3pPr marL="679216" indent="0">
              <a:buNone/>
              <a:defRPr sz="1300" b="1"/>
            </a:lvl3pPr>
            <a:lvl4pPr marL="1018824" indent="0">
              <a:buNone/>
              <a:defRPr sz="1200" b="1"/>
            </a:lvl4pPr>
            <a:lvl5pPr marL="1358433" indent="0">
              <a:buNone/>
              <a:defRPr sz="1200" b="1"/>
            </a:lvl5pPr>
            <a:lvl6pPr marL="1698041" indent="0">
              <a:buNone/>
              <a:defRPr sz="1200" b="1"/>
            </a:lvl6pPr>
            <a:lvl7pPr marL="2037649" indent="0">
              <a:buNone/>
              <a:defRPr sz="1200" b="1"/>
            </a:lvl7pPr>
            <a:lvl8pPr marL="2377257" indent="0">
              <a:buNone/>
              <a:defRPr sz="1200" b="1"/>
            </a:lvl8pPr>
            <a:lvl9pPr marL="2716865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74320" y="1449917"/>
            <a:ext cx="2424113" cy="2634192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787015" y="1023409"/>
            <a:ext cx="2425065" cy="426508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39608" indent="0">
              <a:buNone/>
              <a:defRPr sz="1500" b="1"/>
            </a:lvl2pPr>
            <a:lvl3pPr marL="679216" indent="0">
              <a:buNone/>
              <a:defRPr sz="1300" b="1"/>
            </a:lvl3pPr>
            <a:lvl4pPr marL="1018824" indent="0">
              <a:buNone/>
              <a:defRPr sz="1200" b="1"/>
            </a:lvl4pPr>
            <a:lvl5pPr marL="1358433" indent="0">
              <a:buNone/>
              <a:defRPr sz="1200" b="1"/>
            </a:lvl5pPr>
            <a:lvl6pPr marL="1698041" indent="0">
              <a:buNone/>
              <a:defRPr sz="1200" b="1"/>
            </a:lvl6pPr>
            <a:lvl7pPr marL="2037649" indent="0">
              <a:buNone/>
              <a:defRPr sz="1200" b="1"/>
            </a:lvl7pPr>
            <a:lvl8pPr marL="2377257" indent="0">
              <a:buNone/>
              <a:defRPr sz="1200" b="1"/>
            </a:lvl8pPr>
            <a:lvl9pPr marL="2716865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787015" y="1449917"/>
            <a:ext cx="2425065" cy="2634192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7E52E-931C-4507-944B-6ED7C09526FE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52905-D9BA-43FD-B8CB-B5F87BD853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56530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7E52E-931C-4507-944B-6ED7C09526FE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52905-D9BA-43FD-B8CB-B5F87BD853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12982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7E52E-931C-4507-944B-6ED7C09526FE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52905-D9BA-43FD-B8CB-B5F87BD853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30750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74321" y="182033"/>
            <a:ext cx="1804988" cy="7747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145030" y="182035"/>
            <a:ext cx="3067050" cy="390207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74321" y="956734"/>
            <a:ext cx="1804988" cy="3127375"/>
          </a:xfrm>
        </p:spPr>
        <p:txBody>
          <a:bodyPr/>
          <a:lstStyle>
            <a:lvl1pPr marL="0" indent="0">
              <a:buNone/>
              <a:defRPr sz="1000"/>
            </a:lvl1pPr>
            <a:lvl2pPr marL="339608" indent="0">
              <a:buNone/>
              <a:defRPr sz="900"/>
            </a:lvl2pPr>
            <a:lvl3pPr marL="679216" indent="0">
              <a:buNone/>
              <a:defRPr sz="700"/>
            </a:lvl3pPr>
            <a:lvl4pPr marL="1018824" indent="0">
              <a:buNone/>
              <a:defRPr sz="700"/>
            </a:lvl4pPr>
            <a:lvl5pPr marL="1358433" indent="0">
              <a:buNone/>
              <a:defRPr sz="700"/>
            </a:lvl5pPr>
            <a:lvl6pPr marL="1698041" indent="0">
              <a:buNone/>
              <a:defRPr sz="700"/>
            </a:lvl6pPr>
            <a:lvl7pPr marL="2037649" indent="0">
              <a:buNone/>
              <a:defRPr sz="700"/>
            </a:lvl7pPr>
            <a:lvl8pPr marL="2377257" indent="0">
              <a:buNone/>
              <a:defRPr sz="700"/>
            </a:lvl8pPr>
            <a:lvl9pPr marL="2716865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7E52E-931C-4507-944B-6ED7C09526FE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52905-D9BA-43FD-B8CB-B5F87BD853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98420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5373" y="3200401"/>
            <a:ext cx="3291840" cy="377825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075373" y="408517"/>
            <a:ext cx="3291840" cy="2743200"/>
          </a:xfrm>
        </p:spPr>
        <p:txBody>
          <a:bodyPr/>
          <a:lstStyle>
            <a:lvl1pPr marL="0" indent="0">
              <a:buNone/>
              <a:defRPr sz="2400"/>
            </a:lvl1pPr>
            <a:lvl2pPr marL="339608" indent="0">
              <a:buNone/>
              <a:defRPr sz="2100"/>
            </a:lvl2pPr>
            <a:lvl3pPr marL="679216" indent="0">
              <a:buNone/>
              <a:defRPr sz="1800"/>
            </a:lvl3pPr>
            <a:lvl4pPr marL="1018824" indent="0">
              <a:buNone/>
              <a:defRPr sz="1500"/>
            </a:lvl4pPr>
            <a:lvl5pPr marL="1358433" indent="0">
              <a:buNone/>
              <a:defRPr sz="1500"/>
            </a:lvl5pPr>
            <a:lvl6pPr marL="1698041" indent="0">
              <a:buNone/>
              <a:defRPr sz="1500"/>
            </a:lvl6pPr>
            <a:lvl7pPr marL="2037649" indent="0">
              <a:buNone/>
              <a:defRPr sz="1500"/>
            </a:lvl7pPr>
            <a:lvl8pPr marL="2377257" indent="0">
              <a:buNone/>
              <a:defRPr sz="1500"/>
            </a:lvl8pPr>
            <a:lvl9pPr marL="2716865" indent="0">
              <a:buNone/>
              <a:defRPr sz="15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75373" y="3578226"/>
            <a:ext cx="3291840" cy="536575"/>
          </a:xfrm>
        </p:spPr>
        <p:txBody>
          <a:bodyPr/>
          <a:lstStyle>
            <a:lvl1pPr marL="0" indent="0">
              <a:buNone/>
              <a:defRPr sz="1000"/>
            </a:lvl1pPr>
            <a:lvl2pPr marL="339608" indent="0">
              <a:buNone/>
              <a:defRPr sz="900"/>
            </a:lvl2pPr>
            <a:lvl3pPr marL="679216" indent="0">
              <a:buNone/>
              <a:defRPr sz="700"/>
            </a:lvl3pPr>
            <a:lvl4pPr marL="1018824" indent="0">
              <a:buNone/>
              <a:defRPr sz="700"/>
            </a:lvl4pPr>
            <a:lvl5pPr marL="1358433" indent="0">
              <a:buNone/>
              <a:defRPr sz="700"/>
            </a:lvl5pPr>
            <a:lvl6pPr marL="1698041" indent="0">
              <a:buNone/>
              <a:defRPr sz="700"/>
            </a:lvl6pPr>
            <a:lvl7pPr marL="2037649" indent="0">
              <a:buNone/>
              <a:defRPr sz="700"/>
            </a:lvl7pPr>
            <a:lvl8pPr marL="2377257" indent="0">
              <a:buNone/>
              <a:defRPr sz="700"/>
            </a:lvl8pPr>
            <a:lvl9pPr marL="2716865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A7E52E-931C-4507-944B-6ED7C09526FE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52905-D9BA-43FD-B8CB-B5F87BD853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45977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74320" y="183092"/>
            <a:ext cx="4937760" cy="762000"/>
          </a:xfrm>
          <a:prstGeom prst="rect">
            <a:avLst/>
          </a:prstGeom>
        </p:spPr>
        <p:txBody>
          <a:bodyPr vert="horz" lIns="67922" tIns="33961" rIns="67922" bIns="33961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74320" y="1066801"/>
            <a:ext cx="4937760" cy="3017309"/>
          </a:xfrm>
          <a:prstGeom prst="rect">
            <a:avLst/>
          </a:prstGeom>
        </p:spPr>
        <p:txBody>
          <a:bodyPr vert="horz" lIns="67922" tIns="33961" rIns="67922" bIns="33961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74320" y="4237568"/>
            <a:ext cx="1280160" cy="243417"/>
          </a:xfrm>
          <a:prstGeom prst="rect">
            <a:avLst/>
          </a:prstGeom>
        </p:spPr>
        <p:txBody>
          <a:bodyPr vert="horz" lIns="67922" tIns="33961" rIns="67922" bIns="33961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A7E52E-931C-4507-944B-6ED7C09526FE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874520" y="4237568"/>
            <a:ext cx="1737360" cy="243417"/>
          </a:xfrm>
          <a:prstGeom prst="rect">
            <a:avLst/>
          </a:prstGeom>
        </p:spPr>
        <p:txBody>
          <a:bodyPr vert="horz" lIns="67922" tIns="33961" rIns="67922" bIns="33961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931920" y="4237568"/>
            <a:ext cx="1280160" cy="243417"/>
          </a:xfrm>
          <a:prstGeom prst="rect">
            <a:avLst/>
          </a:prstGeom>
        </p:spPr>
        <p:txBody>
          <a:bodyPr vert="horz" lIns="67922" tIns="33961" rIns="67922" bIns="33961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C52905-D9BA-43FD-B8CB-B5F87BD8530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43204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79216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4706" indent="-254706" algn="l" defTabSz="679216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1863" indent="-212255" algn="l" defTabSz="679216" rtl="0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49020" indent="-169804" algn="l" defTabSz="679216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188629" indent="-169804" algn="l" defTabSz="679216" rtl="0" eaLnBrk="1" latinLnBrk="0" hangingPunct="1">
        <a:spcBef>
          <a:spcPct val="20000"/>
        </a:spcBef>
        <a:buFont typeface="Arial" panose="020B0604020202020204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28237" indent="-169804" algn="l" defTabSz="679216" rtl="0" eaLnBrk="1" latinLnBrk="0" hangingPunct="1">
        <a:spcBef>
          <a:spcPct val="20000"/>
        </a:spcBef>
        <a:buFont typeface="Arial" panose="020B0604020202020204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67845" indent="-169804" algn="l" defTabSz="679216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07453" indent="-169804" algn="l" defTabSz="679216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47061" indent="-169804" algn="l" defTabSz="679216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886669" indent="-169804" algn="l" defTabSz="679216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79216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1pPr>
      <a:lvl2pPr marL="339608" algn="l" defTabSz="679216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2pPr>
      <a:lvl3pPr marL="679216" algn="l" defTabSz="679216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3pPr>
      <a:lvl4pPr marL="1018824" algn="l" defTabSz="679216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358433" algn="l" defTabSz="679216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698041" algn="l" defTabSz="679216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6pPr>
      <a:lvl7pPr marL="2037649" algn="l" defTabSz="679216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7pPr>
      <a:lvl8pPr marL="2377257" algn="l" defTabSz="679216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8pPr>
      <a:lvl9pPr marL="2716865" algn="l" defTabSz="679216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/>
        </p:nvGrpSpPr>
        <p:grpSpPr>
          <a:xfrm>
            <a:off x="457200" y="304800"/>
            <a:ext cx="4572000" cy="2743200"/>
            <a:chOff x="1295400" y="5181600"/>
            <a:chExt cx="4572000" cy="2743200"/>
          </a:xfrm>
        </p:grpSpPr>
        <p:graphicFrame>
          <p:nvGraphicFramePr>
            <p:cNvPr id="15" name="Chart 1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53697295"/>
                </p:ext>
              </p:extLst>
            </p:nvPr>
          </p:nvGraphicFramePr>
          <p:xfrm>
            <a:off x="1295400" y="5181600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cxnSp>
          <p:nvCxnSpPr>
            <p:cNvPr id="16" name="Straight Arrow Connector 15"/>
            <p:cNvCxnSpPr/>
            <p:nvPr/>
          </p:nvCxnSpPr>
          <p:spPr>
            <a:xfrm>
              <a:off x="4495800" y="6705600"/>
              <a:ext cx="233903" cy="202037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7" name="TextBox 16"/>
            <p:cNvSpPr txBox="1"/>
            <p:nvPr/>
          </p:nvSpPr>
          <p:spPr>
            <a:xfrm>
              <a:off x="4612751" y="7162800"/>
              <a:ext cx="72124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r>
                <a:rPr lang="en-US" sz="2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=8</a:t>
              </a:r>
              <a:endParaRPr lang="en-GB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8" name="Rectangle 17"/>
          <p:cNvSpPr/>
          <p:nvPr/>
        </p:nvSpPr>
        <p:spPr>
          <a:xfrm>
            <a:off x="521015" y="3200400"/>
            <a:ext cx="4572000" cy="830997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 Fig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opulation structure results using 31,253 SNPs. Log probability data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Ln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D) as function of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k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number of groups) from the structure run. The plateau of the graph at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= 8 indicates the optimum number of subgroups possible in th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anel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6200000">
            <a:off x="-105462" y="1400402"/>
            <a:ext cx="9144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n P(D)</a:t>
            </a:r>
            <a:endParaRPr lang="en-GB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124200" y="326411"/>
            <a:ext cx="381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endParaRPr lang="en-GB" sz="16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79638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56</Words>
  <Application>Microsoft Office PowerPoint</Application>
  <PresentationFormat>Custom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hanapal, Arun P.</dc:creator>
  <cp:lastModifiedBy>Dhanapal, Arun P.</cp:lastModifiedBy>
  <cp:revision>1</cp:revision>
  <dcterms:created xsi:type="dcterms:W3CDTF">2015-08-07T21:45:16Z</dcterms:created>
  <dcterms:modified xsi:type="dcterms:W3CDTF">2015-08-07T21:48:53Z</dcterms:modified>
</cp:coreProperties>
</file>